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谷本　昌太" initials="谷本　昌太" lastIdx="1" clrIdx="0">
    <p:extLst>
      <p:ext uri="{19B8F6BF-5375-455C-9EA6-DF929625EA0E}">
        <p15:presenceInfo xmlns:p15="http://schemas.microsoft.com/office/powerpoint/2012/main" userId="S-1-5-21-726395537-1888609281-952689124-1001" providerId="AD"/>
      </p:ext>
    </p:extLst>
  </p:cmAuthor>
  <p:cmAuthor id="2" name="谷本　昌太" initials="谷本　昌太 [2]" lastIdx="9" clrIdx="1">
    <p:extLst>
      <p:ext uri="{19B8F6BF-5375-455C-9EA6-DF929625EA0E}">
        <p15:presenceInfo xmlns:p15="http://schemas.microsoft.com/office/powerpoint/2012/main" userId="谷本　昌太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5829" autoAdjust="0"/>
  </p:normalViewPr>
  <p:slideViewPr>
    <p:cSldViewPr snapToGrid="0">
      <p:cViewPr varScale="1">
        <p:scale>
          <a:sx n="95" d="100"/>
          <a:sy n="95" d="100"/>
        </p:scale>
        <p:origin x="58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98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46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8032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463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419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053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0685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993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429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193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243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EDE31-5717-4D2F-8935-860290B72DA0}" type="datetimeFigureOut">
              <a:rPr kumimoji="1" lang="ja-JP" altLang="en-US" smtClean="0"/>
              <a:t>2026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F9578-4645-4BD6-9291-24AD64D89C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0568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7814B73-AEF6-4B41-8AF2-4EA80DDA82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61" y="715327"/>
            <a:ext cx="4851644" cy="2988000"/>
          </a:xfrm>
          <a:prstGeom prst="rect">
            <a:avLst/>
          </a:prstGeom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1C6643D-A69B-4246-BBE0-FA3D11098A5A}"/>
              </a:ext>
            </a:extLst>
          </p:cNvPr>
          <p:cNvSpPr txBox="1"/>
          <p:nvPr/>
        </p:nvSpPr>
        <p:spPr>
          <a:xfrm>
            <a:off x="509512" y="4161982"/>
            <a:ext cx="89364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plot by volatile organic compounds (VOCs) in oyster meat during storage at different temperature.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Score plot. (b) Loading plot. (a) Score plot, O: oyster meat; 0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℃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lue,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range. Day 0: circle (green color), Day 1: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, Day 3: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angle, Day 7: square, Day 12: diamond. (b) Loading plot, the numbers indicate the peak numbers of VOCs, corresponds to</a:t>
            </a:r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F8071D7-ACC2-446F-A661-91DF30702F48}"/>
              </a:ext>
            </a:extLst>
          </p:cNvPr>
          <p:cNvGrpSpPr/>
          <p:nvPr/>
        </p:nvGrpSpPr>
        <p:grpSpPr>
          <a:xfrm>
            <a:off x="4953000" y="719516"/>
            <a:ext cx="4848738" cy="2986210"/>
            <a:chOff x="5034341" y="3189585"/>
            <a:chExt cx="4848738" cy="2986210"/>
          </a:xfrm>
        </p:grpSpPr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C0814354-7C42-4517-B051-8BA5839831D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34341" y="3189585"/>
              <a:ext cx="4848738" cy="2986210"/>
            </a:xfrm>
            <a:prstGeom prst="rect">
              <a:avLst/>
            </a:prstGeom>
          </p:spPr>
        </p:pic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B73C6A2F-EC45-457D-930E-CE5660627C78}"/>
                </a:ext>
              </a:extLst>
            </p:cNvPr>
            <p:cNvCxnSpPr>
              <a:cxnSpLocks/>
            </p:cNvCxnSpPr>
            <p:nvPr/>
          </p:nvCxnSpPr>
          <p:spPr>
            <a:xfrm>
              <a:off x="5886963" y="4759036"/>
              <a:ext cx="85248" cy="638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8">
              <a:extLst>
                <a:ext uri="{FF2B5EF4-FFF2-40B4-BE49-F238E27FC236}">
                  <a16:creationId xmlns:a16="http://schemas.microsoft.com/office/drawing/2014/main" id="{1725EF45-EDD0-42BF-A9EA-3D0F497F2E00}"/>
                </a:ext>
              </a:extLst>
            </p:cNvPr>
            <p:cNvSpPr txBox="1"/>
            <p:nvPr/>
          </p:nvSpPr>
          <p:spPr>
            <a:xfrm>
              <a:off x="5828295" y="5350754"/>
              <a:ext cx="1088104" cy="27086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hanol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094B5E6D-68D3-43A2-AC5A-1D1094941CD8}"/>
                </a:ext>
              </a:extLst>
            </p:cNvPr>
            <p:cNvCxnSpPr>
              <a:cxnSpLocks/>
            </p:cNvCxnSpPr>
            <p:nvPr/>
          </p:nvCxnSpPr>
          <p:spPr>
            <a:xfrm>
              <a:off x="5972211" y="4810736"/>
              <a:ext cx="320161" cy="36849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8">
              <a:extLst>
                <a:ext uri="{FF2B5EF4-FFF2-40B4-BE49-F238E27FC236}">
                  <a16:creationId xmlns:a16="http://schemas.microsoft.com/office/drawing/2014/main" id="{8546F6E7-3992-40D7-897D-7E42BA2975FC}"/>
                </a:ext>
              </a:extLst>
            </p:cNvPr>
            <p:cNvSpPr txBox="1"/>
            <p:nvPr/>
          </p:nvSpPr>
          <p:spPr>
            <a:xfrm>
              <a:off x="6238124" y="5043802"/>
              <a:ext cx="1088104" cy="27086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Propanol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8">
              <a:extLst>
                <a:ext uri="{FF2B5EF4-FFF2-40B4-BE49-F238E27FC236}">
                  <a16:creationId xmlns:a16="http://schemas.microsoft.com/office/drawing/2014/main" id="{88852367-8EF2-42DE-8C18-3860D913A16F}"/>
                </a:ext>
              </a:extLst>
            </p:cNvPr>
            <p:cNvSpPr txBox="1"/>
            <p:nvPr/>
          </p:nvSpPr>
          <p:spPr>
            <a:xfrm>
              <a:off x="5470941" y="5488462"/>
              <a:ext cx="1088104" cy="27086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ic acid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222257A4-C3A9-4B97-80EC-99661A2D18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43784" y="4425962"/>
              <a:ext cx="92608" cy="1080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AD2CFCB7-9086-4FF8-881B-51CE0DB50233}"/>
                </a:ext>
              </a:extLst>
            </p:cNvPr>
            <p:cNvCxnSpPr>
              <a:cxnSpLocks/>
            </p:cNvCxnSpPr>
            <p:nvPr/>
          </p:nvCxnSpPr>
          <p:spPr>
            <a:xfrm>
              <a:off x="5948437" y="4969135"/>
              <a:ext cx="183854" cy="2860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8">
              <a:extLst>
                <a:ext uri="{FF2B5EF4-FFF2-40B4-BE49-F238E27FC236}">
                  <a16:creationId xmlns:a16="http://schemas.microsoft.com/office/drawing/2014/main" id="{726542F4-9937-4421-AD1E-CB0492C809A4}"/>
                </a:ext>
              </a:extLst>
            </p:cNvPr>
            <p:cNvSpPr txBox="1"/>
            <p:nvPr/>
          </p:nvSpPr>
          <p:spPr>
            <a:xfrm>
              <a:off x="6067065" y="5180713"/>
              <a:ext cx="1152466" cy="24999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panoic acid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C980089-57AE-4E4C-BBDB-5CDF626E6265}"/>
              </a:ext>
            </a:extLst>
          </p:cNvPr>
          <p:cNvSpPr txBox="1"/>
          <p:nvPr/>
        </p:nvSpPr>
        <p:spPr>
          <a:xfrm>
            <a:off x="4864930" y="966126"/>
            <a:ext cx="525880" cy="253915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5</a:t>
            </a: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</a:p>
          <a:p>
            <a:pPr algn="r"/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05</a:t>
            </a:r>
          </a:p>
          <a:p>
            <a:pPr algn="r"/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1</a:t>
            </a:r>
          </a:p>
          <a:p>
            <a:pPr algn="r"/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15</a:t>
            </a:r>
          </a:p>
          <a:p>
            <a:pPr algn="r"/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2</a:t>
            </a:r>
          </a:p>
        </p:txBody>
      </p:sp>
      <p:sp>
        <p:nvSpPr>
          <p:cNvPr id="23" name="楕円 22">
            <a:extLst>
              <a:ext uri="{FF2B5EF4-FFF2-40B4-BE49-F238E27FC236}">
                <a16:creationId xmlns:a16="http://schemas.microsoft.com/office/drawing/2014/main" id="{2E48A439-B526-4F46-9BB6-07679B85B5AA}"/>
              </a:ext>
            </a:extLst>
          </p:cNvPr>
          <p:cNvSpPr/>
          <p:nvPr/>
        </p:nvSpPr>
        <p:spPr>
          <a:xfrm rot="21280275">
            <a:off x="5520596" y="1498449"/>
            <a:ext cx="1003554" cy="549813"/>
          </a:xfrm>
          <a:prstGeom prst="ellipse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8">
            <a:extLst>
              <a:ext uri="{FF2B5EF4-FFF2-40B4-BE49-F238E27FC236}">
                <a16:creationId xmlns:a16="http://schemas.microsoft.com/office/drawing/2014/main" id="{4C2B7A7E-A00A-44EA-B4DA-0791060DC88C}"/>
              </a:ext>
            </a:extLst>
          </p:cNvPr>
          <p:cNvSpPr txBox="1"/>
          <p:nvPr/>
        </p:nvSpPr>
        <p:spPr>
          <a:xfrm>
            <a:off x="5443699" y="1083180"/>
            <a:ext cx="1088104" cy="2708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dehydes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63ED9FF-3944-446B-8155-F94484D6E322}"/>
              </a:ext>
            </a:extLst>
          </p:cNvPr>
          <p:cNvCxnSpPr>
            <a:cxnSpLocks/>
            <a:stCxn id="23" idx="0"/>
          </p:cNvCxnSpPr>
          <p:nvPr/>
        </p:nvCxnSpPr>
        <p:spPr>
          <a:xfrm flipH="1" flipV="1">
            <a:off x="5713420" y="1329925"/>
            <a:ext cx="283422" cy="1697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6A90E29-2FD7-4DF9-939C-55E7352941A2}"/>
              </a:ext>
            </a:extLst>
          </p:cNvPr>
          <p:cNvSpPr txBox="1"/>
          <p:nvPr/>
        </p:nvSpPr>
        <p:spPr>
          <a:xfrm>
            <a:off x="64636" y="1309615"/>
            <a:ext cx="398762" cy="21390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  <a:p>
            <a:pPr algn="r"/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0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C4D62C7-29C5-4EB8-8FBC-37387B0AC92E}"/>
              </a:ext>
            </a:extLst>
          </p:cNvPr>
          <p:cNvSpPr txBox="1"/>
          <p:nvPr/>
        </p:nvSpPr>
        <p:spPr>
          <a:xfrm>
            <a:off x="363101" y="3359786"/>
            <a:ext cx="472614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0             -15             -10              -5                 0                5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DD15BE1-6262-4AC7-960E-2791B41CDA3B}"/>
              </a:ext>
            </a:extLst>
          </p:cNvPr>
          <p:cNvSpPr txBox="1"/>
          <p:nvPr/>
        </p:nvSpPr>
        <p:spPr>
          <a:xfrm>
            <a:off x="9140" y="735472"/>
            <a:ext cx="45425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[2]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60DB412-4FFC-4F14-957B-E18778F8DD21}"/>
              </a:ext>
            </a:extLst>
          </p:cNvPr>
          <p:cNvSpPr txBox="1"/>
          <p:nvPr/>
        </p:nvSpPr>
        <p:spPr>
          <a:xfrm>
            <a:off x="4460882" y="3343258"/>
            <a:ext cx="43639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[1]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65D95E0-0853-4590-99D2-24129FEE4210}"/>
              </a:ext>
            </a:extLst>
          </p:cNvPr>
          <p:cNvSpPr txBox="1"/>
          <p:nvPr/>
        </p:nvSpPr>
        <p:spPr>
          <a:xfrm>
            <a:off x="5223314" y="3360629"/>
            <a:ext cx="409951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15           -0.1           -0.05             0               0.05            0.1    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B876D47-0487-4C78-A815-D36F6D03AABC}"/>
              </a:ext>
            </a:extLst>
          </p:cNvPr>
          <p:cNvSpPr txBox="1"/>
          <p:nvPr/>
        </p:nvSpPr>
        <p:spPr>
          <a:xfrm>
            <a:off x="9334310" y="3363339"/>
            <a:ext cx="4509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[1]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6741788-68C7-4623-B7EB-74B989BE7208}"/>
              </a:ext>
            </a:extLst>
          </p:cNvPr>
          <p:cNvSpPr txBox="1"/>
          <p:nvPr/>
        </p:nvSpPr>
        <p:spPr>
          <a:xfrm>
            <a:off x="4903201" y="716238"/>
            <a:ext cx="4988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[2]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F76837F2-A404-41C8-946B-6A4C2DEDC97B}"/>
              </a:ext>
            </a:extLst>
          </p:cNvPr>
          <p:cNvSpPr txBox="1"/>
          <p:nvPr/>
        </p:nvSpPr>
        <p:spPr>
          <a:xfrm>
            <a:off x="1644964" y="3618016"/>
            <a:ext cx="22781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2x[1] = 0.463, R2x[2] =  0.162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ED6981A-3616-429B-B3F2-1647C18499EA}"/>
              </a:ext>
            </a:extLst>
          </p:cNvPr>
          <p:cNvSpPr txBox="1"/>
          <p:nvPr/>
        </p:nvSpPr>
        <p:spPr>
          <a:xfrm>
            <a:off x="6466875" y="3604607"/>
            <a:ext cx="22781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2x[1] = 0.463, R2x[2] =  0.162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9B11FBB-8A75-4E1D-993F-0213DD849224}"/>
              </a:ext>
            </a:extLst>
          </p:cNvPr>
          <p:cNvSpPr txBox="1"/>
          <p:nvPr/>
        </p:nvSpPr>
        <p:spPr>
          <a:xfrm>
            <a:off x="93255" y="406509"/>
            <a:ext cx="6599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                                                                                b)</a:t>
            </a:r>
          </a:p>
        </p:txBody>
      </p:sp>
    </p:spTree>
    <p:extLst>
      <p:ext uri="{BB962C8B-B14F-4D97-AF65-F5344CB8AC3E}">
        <p14:creationId xmlns:p14="http://schemas.microsoft.com/office/powerpoint/2010/main" val="4133623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93</TotalTime>
  <Words>195</Words>
  <Application>Microsoft Office PowerPoint</Application>
  <PresentationFormat>A4 210 x 297 mm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壁　奈央</dc:creator>
  <cp:lastModifiedBy>渡壁　奈央</cp:lastModifiedBy>
  <cp:revision>166</cp:revision>
  <dcterms:created xsi:type="dcterms:W3CDTF">2025-05-15T09:01:22Z</dcterms:created>
  <dcterms:modified xsi:type="dcterms:W3CDTF">2026-01-23T12:10:36Z</dcterms:modified>
</cp:coreProperties>
</file>